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fi-FI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0" d="100"/>
          <a:sy n="80" d="100"/>
        </p:scale>
        <p:origin x="58" y="1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81E374-F7C7-4697-BD28-337E289FB1B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3744546-8AF9-4929-8F58-F01020EB9F7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fi-FI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01EF82-E1E1-4B90-9C60-C374989AE1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2D9D35-E5E9-49FA-A950-B99F0329CEE0}" type="datetimeFigureOut">
              <a:rPr lang="fi-FI" smtClean="0"/>
              <a:t>12.12.2022</a:t>
            </a:fld>
            <a:endParaRPr lang="fi-FI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B7F41C-0FC8-4FD2-8D9F-F468C54D57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EA6541-5897-457A-9417-30A42916D6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09575-C551-49E0-A56F-777E59959417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8753678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977532-7B66-481C-B062-2AF429D24C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F73C118-CC51-407A-B36C-700DC0628C8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D530E8-BE4E-4800-BD52-B3FDBEF9A2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2D9D35-E5E9-49FA-A950-B99F0329CEE0}" type="datetimeFigureOut">
              <a:rPr lang="fi-FI" smtClean="0"/>
              <a:t>12.12.2022</a:t>
            </a:fld>
            <a:endParaRPr lang="fi-FI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A4F84A-F50C-409F-8F93-4F8B6CAFFB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FB3544E-72D0-486C-9BF9-615268687F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09575-C551-49E0-A56F-777E59959417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4166700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33FB9FA-C42E-498F-8846-D3501A8D022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3621B70-73F8-482A-9830-DB1C76041B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9DDA55-75A0-4E7C-92D4-592A1AB979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2D9D35-E5E9-49FA-A950-B99F0329CEE0}" type="datetimeFigureOut">
              <a:rPr lang="fi-FI" smtClean="0"/>
              <a:t>12.12.2022</a:t>
            </a:fld>
            <a:endParaRPr lang="fi-FI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1F6CA1-29F1-4F66-9740-0D26F61A6A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A29ECC-A9DB-4932-8C64-33380F3A00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09575-C551-49E0-A56F-777E59959417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9361331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8C81E2-5D54-4E63-95A7-35EC99B8DA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AF7D6C7-F88E-4F60-94F0-8B3ABF805DA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4BE477-64E6-4869-BDB1-EA7EF2AD3F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2D9D35-E5E9-49FA-A950-B99F0329CEE0}" type="datetimeFigureOut">
              <a:rPr lang="fi-FI" smtClean="0"/>
              <a:t>12.12.2022</a:t>
            </a:fld>
            <a:endParaRPr lang="fi-FI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86C1D8-616F-4095-B1A4-1C6320258F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F31F55-FF60-46CA-91D2-E04534A233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09575-C551-49E0-A56F-777E59959417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6513138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CD3E95-7B9F-4E5C-A520-756FFED735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C0384CF-AA36-4DDA-9731-7EEF344DD2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623EA6-0B54-4622-A8DD-60555CA1AB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2D9D35-E5E9-49FA-A950-B99F0329CEE0}" type="datetimeFigureOut">
              <a:rPr lang="fi-FI" smtClean="0"/>
              <a:t>12.12.2022</a:t>
            </a:fld>
            <a:endParaRPr lang="fi-FI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4B297C-CEB9-42B7-9882-CDB4DAE88A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28F72C-EA8E-4D97-BFCE-68AC12625B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09575-C551-49E0-A56F-777E59959417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42188437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B489B2-8C84-4D8F-B327-D9C3D4DCB6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C379C15-337B-48F1-85D2-15B04087E99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58F63E4-CF2A-44B2-9E81-4F306FDD379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1F5E751-3A3A-4667-A3D0-1BBEF0D083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2D9D35-E5E9-49FA-A950-B99F0329CEE0}" type="datetimeFigureOut">
              <a:rPr lang="fi-FI" smtClean="0"/>
              <a:t>12.12.2022</a:t>
            </a:fld>
            <a:endParaRPr lang="fi-FI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0917A4C-A3DF-4556-9F56-C81598C868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305D754-291C-4E3D-B59C-0781190711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09575-C551-49E0-A56F-777E59959417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5057524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9BC494-8AB4-4AA8-8FDE-F2E0184EAC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0B2979C-B191-449D-A9D1-17147DAF6D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55FB872-3496-4A5A-9733-E184156E521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1C61C1D-0A5D-41CE-92E4-A3C4C453195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2518EB2-75CB-418C-B1F4-900D43CBEC9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C44B86B-224E-4981-8F08-D1EA4E278D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2D9D35-E5E9-49FA-A950-B99F0329CEE0}" type="datetimeFigureOut">
              <a:rPr lang="fi-FI" smtClean="0"/>
              <a:t>12.12.2022</a:t>
            </a:fld>
            <a:endParaRPr lang="fi-FI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6FEFD5E-D872-4373-9046-A4AB27CDA0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A128719-BB48-43D1-844C-5242BA05F0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09575-C551-49E0-A56F-777E59959417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7604002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6CC5D5-DF39-4F11-BBA9-90748F7D34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CBCB68A-4670-46C0-8576-F9E8E77646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2D9D35-E5E9-49FA-A950-B99F0329CEE0}" type="datetimeFigureOut">
              <a:rPr lang="fi-FI" smtClean="0"/>
              <a:t>12.12.2022</a:t>
            </a:fld>
            <a:endParaRPr lang="fi-FI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5FC7ABF-0059-44D4-881F-9068FD88FC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EB6E70D-1C53-43BB-A43E-5AA6B0C6E8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09575-C551-49E0-A56F-777E59959417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4009291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6581F1E-7A6A-48ED-9B6D-4181B8E38B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2D9D35-E5E9-49FA-A950-B99F0329CEE0}" type="datetimeFigureOut">
              <a:rPr lang="fi-FI" smtClean="0"/>
              <a:t>12.12.2022</a:t>
            </a:fld>
            <a:endParaRPr lang="fi-FI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DE8E40C-E7E1-41A9-88B3-A2916DF415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3736210-06B9-4ECB-9FCE-7FDE10EFB8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09575-C551-49E0-A56F-777E59959417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4085356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C59340-C3E6-45C8-B3C6-65DBBBE5B9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6AF072-F6D9-4B33-8543-65762D7761F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9BFBAFF-5173-4BF2-A342-7C67FBEFDDC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01D3B5A-DEB1-427D-BFD6-153F521380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2D9D35-E5E9-49FA-A950-B99F0329CEE0}" type="datetimeFigureOut">
              <a:rPr lang="fi-FI" smtClean="0"/>
              <a:t>12.12.2022</a:t>
            </a:fld>
            <a:endParaRPr lang="fi-FI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2B13FFF-9AAE-4EA3-A387-29DE1023B9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2B7371C-D73B-437E-8E4E-CEF82EAB22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09575-C551-49E0-A56F-777E59959417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7995671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759009-E793-44D0-972D-923F8E5528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6E5286F-19F3-43FB-AC1E-B074FDE4118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i-FI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9E60EEC-5ACA-4812-8862-77514ED7C28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6CE9245-33B3-4AA5-9713-78AC8DAECC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2D9D35-E5E9-49FA-A950-B99F0329CEE0}" type="datetimeFigureOut">
              <a:rPr lang="fi-FI" smtClean="0"/>
              <a:t>12.12.2022</a:t>
            </a:fld>
            <a:endParaRPr lang="fi-FI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932F5CC-915F-4135-B721-1427CC5543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E3D6AA0-05F1-4C9D-909E-561B46D943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09575-C551-49E0-A56F-777E59959417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4051069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9971B43-3AD8-47C7-B32E-5F10D832D4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70CED86-2545-4E8E-9C9D-47C89134763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71BE2F-0FCD-4DEA-A34D-4B4FB67BCC9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2D9D35-E5E9-49FA-A950-B99F0329CEE0}" type="datetimeFigureOut">
              <a:rPr lang="fi-FI" smtClean="0"/>
              <a:t>12.12.2022</a:t>
            </a:fld>
            <a:endParaRPr lang="fi-FI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5D1044-1644-4675-B138-A143DB3A823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i-FI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159CEC-648B-4681-B176-A58C534A259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B09575-C551-49E0-A56F-777E59959417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5505377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i-FI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2.mp4"/><Relationship Id="rId1" Type="http://schemas.microsoft.com/office/2007/relationships/media" Target="../media/media2.mp4"/><Relationship Id="rId4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3.mp4"/><Relationship Id="rId1" Type="http://schemas.microsoft.com/office/2007/relationships/media" Target="../media/media3.mp4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C30DB2-9246-46F1-9A03-459ABD109D60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fi-FI" dirty="0" err="1"/>
              <a:t>Supplementary</a:t>
            </a:r>
            <a:r>
              <a:rPr lang="fi-FI" dirty="0"/>
              <a:t> </a:t>
            </a:r>
            <a:r>
              <a:rPr lang="fi-FI" dirty="0" err="1"/>
              <a:t>Videos</a:t>
            </a:r>
            <a:endParaRPr lang="fi-FI" dirty="0"/>
          </a:p>
        </p:txBody>
      </p:sp>
    </p:spTree>
    <p:extLst>
      <p:ext uri="{BB962C8B-B14F-4D97-AF65-F5344CB8AC3E}">
        <p14:creationId xmlns:p14="http://schemas.microsoft.com/office/powerpoint/2010/main" val="8153822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9ACA2B-B601-45F8-8238-7B18B59C40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i-FI" dirty="0" err="1"/>
              <a:t>Supplementary</a:t>
            </a:r>
            <a:r>
              <a:rPr lang="fi-FI" dirty="0"/>
              <a:t> Video 1.</a:t>
            </a:r>
          </a:p>
        </p:txBody>
      </p:sp>
      <p:pic>
        <p:nvPicPr>
          <p:cNvPr id="4" name="Supplementary Video 1">
            <a:hlinkClick r:id="" action="ppaction://media"/>
            <a:extLst>
              <a:ext uri="{FF2B5EF4-FFF2-40B4-BE49-F238E27FC236}">
                <a16:creationId xmlns:a16="http://schemas.microsoft.com/office/drawing/2014/main" id="{F77806C7-0ED1-47B7-A77B-E421AE4C240A}"/>
              </a:ext>
            </a:extLst>
          </p:cNvPr>
          <p:cNvPicPr>
            <a:picLocks noGrp="1" noChangeAspect="1"/>
          </p:cNvPicPr>
          <p:nvPr>
            <p:ph idx="1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4098925" y="1825625"/>
            <a:ext cx="3994150" cy="4351338"/>
          </a:xfrm>
        </p:spPr>
      </p:pic>
    </p:spTree>
    <p:extLst>
      <p:ext uri="{BB962C8B-B14F-4D97-AF65-F5344CB8AC3E}">
        <p14:creationId xmlns:p14="http://schemas.microsoft.com/office/powerpoint/2010/main" val="291829739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1666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A6AA01-218D-4423-9A09-AA5B0D7C72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i-FI" dirty="0" err="1"/>
              <a:t>Supplementary</a:t>
            </a:r>
            <a:r>
              <a:rPr lang="fi-FI" dirty="0"/>
              <a:t> Video 2.</a:t>
            </a:r>
          </a:p>
        </p:txBody>
      </p:sp>
      <p:pic>
        <p:nvPicPr>
          <p:cNvPr id="4" name="Supplementary Video 2">
            <a:hlinkClick r:id="" action="ppaction://media"/>
            <a:extLst>
              <a:ext uri="{FF2B5EF4-FFF2-40B4-BE49-F238E27FC236}">
                <a16:creationId xmlns:a16="http://schemas.microsoft.com/office/drawing/2014/main" id="{AC1B0816-5C0F-46EF-A8E2-07DF72AC006E}"/>
              </a:ext>
            </a:extLst>
          </p:cNvPr>
          <p:cNvPicPr>
            <a:picLocks noGrp="1" noChangeAspect="1"/>
          </p:cNvPicPr>
          <p:nvPr>
            <p:ph idx="1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3376613" y="1825625"/>
            <a:ext cx="5438775" cy="4351338"/>
          </a:xfrm>
        </p:spPr>
      </p:pic>
    </p:spTree>
    <p:extLst>
      <p:ext uri="{BB962C8B-B14F-4D97-AF65-F5344CB8AC3E}">
        <p14:creationId xmlns:p14="http://schemas.microsoft.com/office/powerpoint/2010/main" val="26015256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6666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A894C2-52A7-411A-B1BA-605C583B9E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i-FI" dirty="0" err="1"/>
              <a:t>Supplementary</a:t>
            </a:r>
            <a:r>
              <a:rPr lang="fi-FI" dirty="0"/>
              <a:t> Video 3.</a:t>
            </a:r>
          </a:p>
        </p:txBody>
      </p:sp>
      <p:pic>
        <p:nvPicPr>
          <p:cNvPr id="4" name="Supplementary Video 3">
            <a:hlinkClick r:id="" action="ppaction://media"/>
            <a:extLst>
              <a:ext uri="{FF2B5EF4-FFF2-40B4-BE49-F238E27FC236}">
                <a16:creationId xmlns:a16="http://schemas.microsoft.com/office/drawing/2014/main" id="{5D2C6D81-CE01-425A-8636-CE11C06B7811}"/>
              </a:ext>
            </a:extLst>
          </p:cNvPr>
          <p:cNvPicPr>
            <a:picLocks noGrp="1" noChangeAspect="1"/>
          </p:cNvPicPr>
          <p:nvPr>
            <p:ph idx="1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3376613" y="1825625"/>
            <a:ext cx="5438775" cy="4351338"/>
          </a:xfrm>
        </p:spPr>
      </p:pic>
    </p:spTree>
    <p:extLst>
      <p:ext uri="{BB962C8B-B14F-4D97-AF65-F5344CB8AC3E}">
        <p14:creationId xmlns:p14="http://schemas.microsoft.com/office/powerpoint/2010/main" val="294624325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8333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</Words>
  <Application>Microsoft Office PowerPoint</Application>
  <PresentationFormat>Widescreen</PresentationFormat>
  <Paragraphs>4</Paragraphs>
  <Slides>4</Slides>
  <Notes>0</Notes>
  <HiddenSlides>0</HiddenSlides>
  <MMClips>3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Supplementary Videos</vt:lpstr>
      <vt:lpstr>Supplementary Video 1.</vt:lpstr>
      <vt:lpstr>Supplementary Video 2.</vt:lpstr>
      <vt:lpstr>Supplementary Video 3.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Videos</dc:title>
  <dc:creator>Lotta Isosaari (TAU)</dc:creator>
  <cp:lastModifiedBy>Lotta Isosaari (TAU)</cp:lastModifiedBy>
  <cp:revision>1</cp:revision>
  <dcterms:created xsi:type="dcterms:W3CDTF">2022-12-12T11:13:00Z</dcterms:created>
  <dcterms:modified xsi:type="dcterms:W3CDTF">2022-12-12T11:30:19Z</dcterms:modified>
</cp:coreProperties>
</file>